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EF745-1073-44A3-8906-1BFE8E376031}" type="datetimeFigureOut">
              <a:rPr lang="ko-KR" altLang="en-US" smtClean="0"/>
              <a:t>2020-0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A1C60-B12E-41F4-BAF5-285C674CAF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20086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EF745-1073-44A3-8906-1BFE8E376031}" type="datetimeFigureOut">
              <a:rPr lang="ko-KR" altLang="en-US" smtClean="0"/>
              <a:t>2020-0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A1C60-B12E-41F4-BAF5-285C674CAF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76518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EF745-1073-44A3-8906-1BFE8E376031}" type="datetimeFigureOut">
              <a:rPr lang="ko-KR" altLang="en-US" smtClean="0"/>
              <a:t>2020-0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A1C60-B12E-41F4-BAF5-285C674CAF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98489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EF745-1073-44A3-8906-1BFE8E376031}" type="datetimeFigureOut">
              <a:rPr lang="ko-KR" altLang="en-US" smtClean="0"/>
              <a:t>2020-0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A1C60-B12E-41F4-BAF5-285C674CAF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53330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EF745-1073-44A3-8906-1BFE8E376031}" type="datetimeFigureOut">
              <a:rPr lang="ko-KR" altLang="en-US" smtClean="0"/>
              <a:t>2020-0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A1C60-B12E-41F4-BAF5-285C674CAF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6801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EF745-1073-44A3-8906-1BFE8E376031}" type="datetimeFigureOut">
              <a:rPr lang="ko-KR" altLang="en-US" smtClean="0"/>
              <a:t>2020-01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A1C60-B12E-41F4-BAF5-285C674CAF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83105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EF745-1073-44A3-8906-1BFE8E376031}" type="datetimeFigureOut">
              <a:rPr lang="ko-KR" altLang="en-US" smtClean="0"/>
              <a:t>2020-01-1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A1C60-B12E-41F4-BAF5-285C674CAF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3209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EF745-1073-44A3-8906-1BFE8E376031}" type="datetimeFigureOut">
              <a:rPr lang="ko-KR" altLang="en-US" smtClean="0"/>
              <a:t>2020-01-1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A1C60-B12E-41F4-BAF5-285C674CAF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46441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EF745-1073-44A3-8906-1BFE8E376031}" type="datetimeFigureOut">
              <a:rPr lang="ko-KR" altLang="en-US" smtClean="0"/>
              <a:t>2020-01-1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A1C60-B12E-41F4-BAF5-285C674CAF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1470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EF745-1073-44A3-8906-1BFE8E376031}" type="datetimeFigureOut">
              <a:rPr lang="ko-KR" altLang="en-US" smtClean="0"/>
              <a:t>2020-01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A1C60-B12E-41F4-BAF5-285C674CAF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38124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EF745-1073-44A3-8906-1BFE8E376031}" type="datetimeFigureOut">
              <a:rPr lang="ko-KR" altLang="en-US" smtClean="0"/>
              <a:t>2020-01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A1C60-B12E-41F4-BAF5-285C674CAF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08914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6EF745-1073-44A3-8906-1BFE8E376031}" type="datetimeFigureOut">
              <a:rPr lang="ko-KR" altLang="en-US" smtClean="0"/>
              <a:t>2020-0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2A1C60-B12E-41F4-BAF5-285C674CAF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98879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/>
          <p:cNvSpPr txBox="1"/>
          <p:nvPr/>
        </p:nvSpPr>
        <p:spPr>
          <a:xfrm>
            <a:off x="1170022" y="5055848"/>
            <a:ext cx="512403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Follow-up after discharge (years) 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21351" y="233970"/>
            <a:ext cx="117496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. Overall in-hospital mortality and post discharge 3-year mortality in HF patients subgroup analysis by de novo HF versus worsening </a:t>
            </a:r>
            <a:r>
              <a:rPr lang="en-US" altLang="ko-KR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ko-KR" smtClean="0">
                <a:latin typeface="Arial" panose="020B0604020202020204" pitchFamily="34" charset="0"/>
                <a:cs typeface="Arial" panose="020B0604020202020204" pitchFamily="34" charset="0"/>
              </a:rPr>
              <a:t>pre-existing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HF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" name="그룹 25"/>
          <p:cNvGrpSpPr/>
          <p:nvPr/>
        </p:nvGrpSpPr>
        <p:grpSpPr>
          <a:xfrm>
            <a:off x="66543" y="1312857"/>
            <a:ext cx="5992946" cy="3930904"/>
            <a:chOff x="434544" y="703122"/>
            <a:chExt cx="8695600" cy="5041628"/>
          </a:xfrm>
        </p:grpSpPr>
        <p:pic>
          <p:nvPicPr>
            <p:cNvPr id="22" name="그림 2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95794" y="703122"/>
              <a:ext cx="8134350" cy="4800600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671964" y="895552"/>
              <a:ext cx="640851" cy="59211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%)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71964" y="1625546"/>
              <a:ext cx="610159" cy="35526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71964" y="2432524"/>
              <a:ext cx="625079" cy="35526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71964" y="3269402"/>
              <a:ext cx="631803" cy="35526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90290" y="4042780"/>
              <a:ext cx="813476" cy="35526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71964" y="4824360"/>
              <a:ext cx="625079" cy="35526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508554" y="5252292"/>
              <a:ext cx="288539" cy="31579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531343" y="5261259"/>
              <a:ext cx="251647" cy="31579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8454488" y="5261259"/>
              <a:ext cx="288539" cy="31579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318748" y="5238203"/>
              <a:ext cx="416776" cy="31579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619986" y="5231584"/>
              <a:ext cx="1200632" cy="5131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-hospital </a:t>
              </a:r>
            </a:p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rtality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직사각형 22"/>
            <p:cNvSpPr/>
            <p:nvPr/>
          </p:nvSpPr>
          <p:spPr>
            <a:xfrm>
              <a:off x="1508095" y="895551"/>
              <a:ext cx="7229505" cy="361294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5" name="그림 4"/>
            <p:cNvPicPr>
              <a:picLocks noChangeAspect="1"/>
            </p:cNvPicPr>
            <p:nvPr/>
          </p:nvPicPr>
          <p:blipFill rotWithShape="1">
            <a:blip r:embed="rId3"/>
            <a:srcRect l="8824" t="5403" r="86078" b="79259"/>
            <a:stretch/>
          </p:blipFill>
          <p:spPr>
            <a:xfrm>
              <a:off x="1710684" y="988915"/>
              <a:ext cx="414866" cy="736601"/>
            </a:xfrm>
            <a:prstGeom prst="rect">
              <a:avLst/>
            </a:prstGeom>
          </p:spPr>
        </p:pic>
        <p:pic>
          <p:nvPicPr>
            <p:cNvPr id="9" name="그림 8"/>
            <p:cNvPicPr>
              <a:picLocks noChangeAspect="1"/>
            </p:cNvPicPr>
            <p:nvPr/>
          </p:nvPicPr>
          <p:blipFill rotWithShape="1">
            <a:blip r:embed="rId4"/>
            <a:srcRect l="8580" t="5114" r="5966" b="36508"/>
            <a:stretch/>
          </p:blipFill>
          <p:spPr>
            <a:xfrm>
              <a:off x="2102103" y="982039"/>
              <a:ext cx="6951133" cy="2802468"/>
            </a:xfrm>
            <a:prstGeom prst="rect">
              <a:avLst/>
            </a:prstGeom>
          </p:spPr>
        </p:pic>
        <p:cxnSp>
          <p:nvCxnSpPr>
            <p:cNvPr id="24" name="직선 연결선 23"/>
            <p:cNvCxnSpPr/>
            <p:nvPr/>
          </p:nvCxnSpPr>
          <p:spPr>
            <a:xfrm>
              <a:off x="2139371" y="765891"/>
              <a:ext cx="0" cy="4433318"/>
            </a:xfrm>
            <a:prstGeom prst="line">
              <a:avLst/>
            </a:prstGeom>
            <a:ln w="285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 rot="16200000">
              <a:off x="-788565" y="2763998"/>
              <a:ext cx="2908918" cy="4627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verall survival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" name="TextBox 5"/>
          <p:cNvSpPr txBox="1"/>
          <p:nvPr/>
        </p:nvSpPr>
        <p:spPr>
          <a:xfrm>
            <a:off x="2743304" y="925395"/>
            <a:ext cx="13727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e novo HF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-36247" y="6333921"/>
            <a:ext cx="9787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4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99436" y="5212479"/>
            <a:ext cx="19997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-36245" y="5502924"/>
            <a:ext cx="9103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-36246" y="5779923"/>
            <a:ext cx="9103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2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-36247" y="6056922"/>
            <a:ext cx="910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3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143165" y="5510452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26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143164" y="5791800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10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143163" y="6069629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43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737461" y="5506060"/>
            <a:ext cx="508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64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737460" y="5787408"/>
            <a:ext cx="508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18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2737459" y="6084287"/>
            <a:ext cx="508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47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4132643" y="5508528"/>
            <a:ext cx="467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12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132643" y="5779570"/>
            <a:ext cx="467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77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4132643" y="6058333"/>
            <a:ext cx="467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87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5474872" y="5508528"/>
            <a:ext cx="510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84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5474871" y="5780351"/>
            <a:ext cx="510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41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5474870" y="6067705"/>
            <a:ext cx="510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43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143163" y="6343716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90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2727934" y="6364763"/>
            <a:ext cx="508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39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4132643" y="6340222"/>
            <a:ext cx="467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85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5474870" y="6341792"/>
            <a:ext cx="510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32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직사각형 49"/>
          <p:cNvSpPr/>
          <p:nvPr/>
        </p:nvSpPr>
        <p:spPr>
          <a:xfrm>
            <a:off x="3868364" y="4831222"/>
            <a:ext cx="247650" cy="18544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1" name="직사각형 50"/>
          <p:cNvSpPr/>
          <p:nvPr/>
        </p:nvSpPr>
        <p:spPr>
          <a:xfrm>
            <a:off x="2297140" y="4859984"/>
            <a:ext cx="247650" cy="18544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2" name="TextBox 51"/>
          <p:cNvSpPr txBox="1"/>
          <p:nvPr/>
        </p:nvSpPr>
        <p:spPr>
          <a:xfrm>
            <a:off x="733772" y="5508528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55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733771" y="5780351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25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733770" y="6067705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71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733770" y="6341792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60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8112072" y="929935"/>
            <a:ext cx="30994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orsening of Chronic HF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7342065" y="5031013"/>
            <a:ext cx="481008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Follow-up after discharge (years) 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7" name="그룹 56"/>
          <p:cNvGrpSpPr/>
          <p:nvPr/>
        </p:nvGrpSpPr>
        <p:grpSpPr>
          <a:xfrm>
            <a:off x="5982739" y="1228447"/>
            <a:ext cx="6210750" cy="3976884"/>
            <a:chOff x="501860" y="903860"/>
            <a:chExt cx="8740856" cy="4957760"/>
          </a:xfrm>
        </p:grpSpPr>
        <p:pic>
          <p:nvPicPr>
            <p:cNvPr id="58" name="그림 5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108366" y="903860"/>
              <a:ext cx="8134350" cy="4800600"/>
            </a:xfrm>
            <a:prstGeom prst="rect">
              <a:avLst/>
            </a:prstGeom>
          </p:spPr>
        </p:pic>
        <p:sp>
          <p:nvSpPr>
            <p:cNvPr id="59" name="TextBox 58"/>
            <p:cNvSpPr txBox="1"/>
            <p:nvPr/>
          </p:nvSpPr>
          <p:spPr>
            <a:xfrm rot="16200000">
              <a:off x="-767933" y="2886216"/>
              <a:ext cx="290891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verall survival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770849" y="1019377"/>
              <a:ext cx="665792" cy="5755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%)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880795" y="1730319"/>
              <a:ext cx="525154" cy="34531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880794" y="2403949"/>
              <a:ext cx="540074" cy="34531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880794" y="3050327"/>
              <a:ext cx="546798" cy="34531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871192" y="3747505"/>
              <a:ext cx="556399" cy="34531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836870" y="4405260"/>
              <a:ext cx="583999" cy="34531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8584633" y="5450610"/>
              <a:ext cx="288539" cy="30695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1443134" y="5428703"/>
              <a:ext cx="416776" cy="30695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직사각형 70"/>
            <p:cNvSpPr/>
            <p:nvPr/>
          </p:nvSpPr>
          <p:spPr>
            <a:xfrm>
              <a:off x="1749112" y="1119760"/>
              <a:ext cx="7318688" cy="40159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880795" y="5033909"/>
              <a:ext cx="549599" cy="34531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3" name="그림 72"/>
            <p:cNvPicPr>
              <a:picLocks noChangeAspect="1"/>
            </p:cNvPicPr>
            <p:nvPr/>
          </p:nvPicPr>
          <p:blipFill rotWithShape="1">
            <a:blip r:embed="rId6"/>
            <a:srcRect l="8782" t="5555" r="84504" b="76720"/>
            <a:stretch/>
          </p:blipFill>
          <p:spPr>
            <a:xfrm>
              <a:off x="1642447" y="1097362"/>
              <a:ext cx="546101" cy="850901"/>
            </a:xfrm>
            <a:prstGeom prst="rect">
              <a:avLst/>
            </a:prstGeom>
          </p:spPr>
        </p:pic>
        <p:pic>
          <p:nvPicPr>
            <p:cNvPr id="74" name="그림 73"/>
            <p:cNvPicPr>
              <a:picLocks noChangeAspect="1"/>
            </p:cNvPicPr>
            <p:nvPr/>
          </p:nvPicPr>
          <p:blipFill rotWithShape="1">
            <a:blip r:embed="rId5"/>
            <a:srcRect l="8601" t="5267" r="5373" b="12458"/>
            <a:stretch/>
          </p:blipFill>
          <p:spPr>
            <a:xfrm>
              <a:off x="2185773" y="1058823"/>
              <a:ext cx="6997700" cy="3949701"/>
            </a:xfrm>
            <a:prstGeom prst="rect">
              <a:avLst/>
            </a:prstGeom>
          </p:spPr>
        </p:pic>
        <p:cxnSp>
          <p:nvCxnSpPr>
            <p:cNvPr id="75" name="직선 연결선 74"/>
            <p:cNvCxnSpPr/>
            <p:nvPr/>
          </p:nvCxnSpPr>
          <p:spPr>
            <a:xfrm>
              <a:off x="2188548" y="981791"/>
              <a:ext cx="0" cy="4433318"/>
            </a:xfrm>
            <a:prstGeom prst="line">
              <a:avLst/>
            </a:prstGeom>
            <a:ln w="285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직사각형 75"/>
            <p:cNvSpPr/>
            <p:nvPr/>
          </p:nvSpPr>
          <p:spPr>
            <a:xfrm>
              <a:off x="2681121" y="5428703"/>
              <a:ext cx="617047" cy="31850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7" name="직사각형 76"/>
            <p:cNvSpPr/>
            <p:nvPr/>
          </p:nvSpPr>
          <p:spPr>
            <a:xfrm>
              <a:off x="4090821" y="5441403"/>
              <a:ext cx="617047" cy="31850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8" name="직사각형 77"/>
            <p:cNvSpPr/>
            <p:nvPr/>
          </p:nvSpPr>
          <p:spPr>
            <a:xfrm>
              <a:off x="5271921" y="5454103"/>
              <a:ext cx="617047" cy="31850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9" name="직사각형 78"/>
            <p:cNvSpPr/>
            <p:nvPr/>
          </p:nvSpPr>
          <p:spPr>
            <a:xfrm>
              <a:off x="6605421" y="5441403"/>
              <a:ext cx="617047" cy="31850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0" name="직사각형 79"/>
            <p:cNvSpPr/>
            <p:nvPr/>
          </p:nvSpPr>
          <p:spPr>
            <a:xfrm>
              <a:off x="7799221" y="5441403"/>
              <a:ext cx="617047" cy="31850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1588331" y="5362825"/>
              <a:ext cx="1260537" cy="4987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-hospital </a:t>
              </a:r>
            </a:p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rtality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6646422" y="5439205"/>
              <a:ext cx="251647" cy="30695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4498063" y="5439577"/>
              <a:ext cx="288539" cy="30695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2" name="TextBox 81"/>
          <p:cNvSpPr txBox="1"/>
          <p:nvPr/>
        </p:nvSpPr>
        <p:spPr>
          <a:xfrm>
            <a:off x="5983553" y="6362496"/>
            <a:ext cx="9787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4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6147811" y="5212479"/>
            <a:ext cx="19997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5983555" y="5502924"/>
            <a:ext cx="9103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5983554" y="5789448"/>
            <a:ext cx="9103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2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5983553" y="6075972"/>
            <a:ext cx="910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3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7039140" y="5510451"/>
            <a:ext cx="485919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21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7039139" y="5791800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43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7039138" y="6079154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90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8666199" y="5504747"/>
            <a:ext cx="508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42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8657607" y="5792101"/>
            <a:ext cx="508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20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8657607" y="6073087"/>
            <a:ext cx="508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06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10210423" y="5500966"/>
            <a:ext cx="467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72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10214773" y="5789095"/>
            <a:ext cx="4670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53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10202283" y="6075971"/>
            <a:ext cx="467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15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11606262" y="5500398"/>
            <a:ext cx="510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30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11606261" y="5791271"/>
            <a:ext cx="510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93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11606260" y="6088150"/>
            <a:ext cx="510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33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7039138" y="6372291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77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8667132" y="6375749"/>
            <a:ext cx="5086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77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10195724" y="6359272"/>
            <a:ext cx="467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96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11606260" y="6371762"/>
            <a:ext cx="5108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43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6724997" y="5508528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40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6724996" y="5789876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70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6724995" y="6077230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24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6724995" y="6360842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35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직선 연결선 106"/>
          <p:cNvCxnSpPr/>
          <p:nvPr/>
        </p:nvCxnSpPr>
        <p:spPr>
          <a:xfrm>
            <a:off x="9826676" y="1631832"/>
            <a:ext cx="29203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8" name="직선 연결선 107"/>
          <p:cNvCxnSpPr/>
          <p:nvPr/>
        </p:nvCxnSpPr>
        <p:spPr>
          <a:xfrm>
            <a:off x="9826676" y="1415713"/>
            <a:ext cx="292034" cy="0"/>
          </a:xfrm>
          <a:prstGeom prst="line">
            <a:avLst/>
          </a:prstGeom>
          <a:ln>
            <a:solidFill>
              <a:srgbClr val="0000FF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9" name="직선 연결선 108"/>
          <p:cNvCxnSpPr/>
          <p:nvPr/>
        </p:nvCxnSpPr>
        <p:spPr>
          <a:xfrm>
            <a:off x="9826676" y="1849085"/>
            <a:ext cx="292034" cy="0"/>
          </a:xfrm>
          <a:prstGeom prst="line">
            <a:avLst/>
          </a:prstGeom>
          <a:ln>
            <a:solidFill>
              <a:schemeClr val="accent6">
                <a:lumMod val="75000"/>
              </a:schemeClr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0" name="TextBox 109"/>
          <p:cNvSpPr txBox="1"/>
          <p:nvPr/>
        </p:nvSpPr>
        <p:spPr>
          <a:xfrm>
            <a:off x="10118709" y="1278817"/>
            <a:ext cx="18614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1 (0.2–2.0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10118710" y="1492764"/>
            <a:ext cx="1524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2 (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.1–3.2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10118709" y="1710586"/>
            <a:ext cx="14931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3 (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.3–5.8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3" name="직선 연결선 112"/>
          <p:cNvCxnSpPr/>
          <p:nvPr/>
        </p:nvCxnSpPr>
        <p:spPr>
          <a:xfrm>
            <a:off x="9826676" y="2072773"/>
            <a:ext cx="292034" cy="0"/>
          </a:xfrm>
          <a:prstGeom prst="line">
            <a:avLst/>
          </a:prstGeom>
          <a:ln>
            <a:solidFill>
              <a:srgbClr val="FF66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4" name="TextBox 113"/>
          <p:cNvSpPr txBox="1"/>
          <p:nvPr/>
        </p:nvSpPr>
        <p:spPr>
          <a:xfrm>
            <a:off x="10118709" y="1928408"/>
            <a:ext cx="1736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4 (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.9–192.4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5" name="직선 연결선 114"/>
          <p:cNvCxnSpPr/>
          <p:nvPr/>
        </p:nvCxnSpPr>
        <p:spPr>
          <a:xfrm>
            <a:off x="4042712" y="1716525"/>
            <a:ext cx="29203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6" name="직선 연결선 115"/>
          <p:cNvCxnSpPr/>
          <p:nvPr/>
        </p:nvCxnSpPr>
        <p:spPr>
          <a:xfrm>
            <a:off x="4042712" y="1500406"/>
            <a:ext cx="292034" cy="0"/>
          </a:xfrm>
          <a:prstGeom prst="line">
            <a:avLst/>
          </a:prstGeom>
          <a:ln>
            <a:solidFill>
              <a:srgbClr val="0000FF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7" name="직선 연결선 116"/>
          <p:cNvCxnSpPr/>
          <p:nvPr/>
        </p:nvCxnSpPr>
        <p:spPr>
          <a:xfrm>
            <a:off x="4042712" y="1933778"/>
            <a:ext cx="292034" cy="0"/>
          </a:xfrm>
          <a:prstGeom prst="line">
            <a:avLst/>
          </a:prstGeom>
          <a:ln>
            <a:solidFill>
              <a:schemeClr val="accent6">
                <a:lumMod val="75000"/>
              </a:schemeClr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8" name="TextBox 117"/>
          <p:cNvSpPr txBox="1"/>
          <p:nvPr/>
        </p:nvSpPr>
        <p:spPr>
          <a:xfrm>
            <a:off x="4334745" y="1363510"/>
            <a:ext cx="18614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1 (0.2–2.0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4334745" y="1577457"/>
            <a:ext cx="15887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2 (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.1–3.2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4334745" y="1795279"/>
            <a:ext cx="14931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3 (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.3–5.8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1" name="직선 연결선 120"/>
          <p:cNvCxnSpPr/>
          <p:nvPr/>
        </p:nvCxnSpPr>
        <p:spPr>
          <a:xfrm>
            <a:off x="4042712" y="2157466"/>
            <a:ext cx="292034" cy="0"/>
          </a:xfrm>
          <a:prstGeom prst="line">
            <a:avLst/>
          </a:prstGeom>
          <a:ln>
            <a:solidFill>
              <a:srgbClr val="FF66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2" name="TextBox 121"/>
          <p:cNvSpPr txBox="1"/>
          <p:nvPr/>
        </p:nvSpPr>
        <p:spPr>
          <a:xfrm>
            <a:off x="4334745" y="2013101"/>
            <a:ext cx="1736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4 (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.9–192.4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10175539" y="3987382"/>
            <a:ext cx="82575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 &lt;0.001</a:t>
            </a:r>
          </a:p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 &lt;0.001</a:t>
            </a:r>
          </a:p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P &lt;0.00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00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2685081" y="3630076"/>
            <a:ext cx="235597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-hospital mortality:  </a:t>
            </a:r>
          </a:p>
          <a:p>
            <a:pPr algn="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month after discharge:</a:t>
            </a:r>
          </a:p>
          <a:p>
            <a:pPr algn="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 months after discharge:</a:t>
            </a:r>
          </a:p>
          <a:p>
            <a:pPr algn="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 years after discharge: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4880548" y="3639597"/>
            <a:ext cx="120898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 &lt;0.001</a:t>
            </a:r>
          </a:p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 &lt;0.001</a:t>
            </a:r>
          </a:p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P &lt;0.00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00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4031211" y="4847162"/>
            <a:ext cx="219594" cy="22951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7" name="직사각형 126"/>
          <p:cNvSpPr/>
          <p:nvPr/>
        </p:nvSpPr>
        <p:spPr>
          <a:xfrm>
            <a:off x="2430805" y="4828788"/>
            <a:ext cx="219594" cy="22951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28" name="직선 연결선 127"/>
          <p:cNvCxnSpPr/>
          <p:nvPr/>
        </p:nvCxnSpPr>
        <p:spPr>
          <a:xfrm>
            <a:off x="1790700" y="1457047"/>
            <a:ext cx="9525" cy="337212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직선 연결선 128"/>
          <p:cNvCxnSpPr/>
          <p:nvPr/>
        </p:nvCxnSpPr>
        <p:spPr>
          <a:xfrm>
            <a:off x="2371725" y="1457047"/>
            <a:ext cx="9525" cy="337212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Box 129"/>
          <p:cNvSpPr txBox="1"/>
          <p:nvPr/>
        </p:nvSpPr>
        <p:spPr>
          <a:xfrm>
            <a:off x="1671220" y="4848636"/>
            <a:ext cx="62717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(mon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2262314" y="4848099"/>
            <a:ext cx="62717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mon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1609890" y="5510452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13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1609889" y="5791800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95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1609888" y="6069629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22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1609888" y="6343716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41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2171865" y="5500927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85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2171864" y="5791800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53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2171863" y="6069629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71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2171863" y="6343716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79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0" name="직선 연결선 139"/>
          <p:cNvCxnSpPr/>
          <p:nvPr/>
        </p:nvCxnSpPr>
        <p:spPr>
          <a:xfrm>
            <a:off x="7654760" y="1327729"/>
            <a:ext cx="31578" cy="3494687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직선 연결선 140"/>
          <p:cNvCxnSpPr/>
          <p:nvPr/>
        </p:nvCxnSpPr>
        <p:spPr>
          <a:xfrm>
            <a:off x="8217429" y="1336472"/>
            <a:ext cx="31578" cy="3494687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TextBox 141"/>
          <p:cNvSpPr txBox="1"/>
          <p:nvPr/>
        </p:nvSpPr>
        <p:spPr>
          <a:xfrm>
            <a:off x="7548091" y="4867335"/>
            <a:ext cx="62717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(mon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8139185" y="4866798"/>
            <a:ext cx="62717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mon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7505865" y="5510451"/>
            <a:ext cx="485919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7505864" y="5791800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15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7505863" y="6079154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40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7505863" y="6372291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34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8048790" y="5510451"/>
            <a:ext cx="485919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76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8048789" y="5791800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7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8048788" y="6079154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78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8048788" y="6372291"/>
            <a:ext cx="48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33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7967221" y="3981732"/>
            <a:ext cx="235597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-hospital mortality:  </a:t>
            </a:r>
          </a:p>
          <a:p>
            <a:pPr algn="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month after discharge:</a:t>
            </a:r>
          </a:p>
          <a:p>
            <a:pPr algn="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 months after discharge:</a:t>
            </a:r>
          </a:p>
          <a:p>
            <a:pPr algn="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 years after discharge: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07742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0" name="그룹 129"/>
          <p:cNvGrpSpPr/>
          <p:nvPr/>
        </p:nvGrpSpPr>
        <p:grpSpPr>
          <a:xfrm>
            <a:off x="17929" y="2028343"/>
            <a:ext cx="4312633" cy="3082625"/>
            <a:chOff x="-733191" y="1450456"/>
            <a:chExt cx="4312633" cy="2951565"/>
          </a:xfrm>
        </p:grpSpPr>
        <p:grpSp>
          <p:nvGrpSpPr>
            <p:cNvPr id="110" name="그룹 109"/>
            <p:cNvGrpSpPr>
              <a:grpSpLocks/>
            </p:cNvGrpSpPr>
            <p:nvPr/>
          </p:nvGrpSpPr>
          <p:grpSpPr>
            <a:xfrm>
              <a:off x="-733191" y="1450456"/>
              <a:ext cx="4312633" cy="2951565"/>
              <a:chOff x="491988" y="1429266"/>
              <a:chExt cx="9003981" cy="5117260"/>
            </a:xfrm>
          </p:grpSpPr>
          <p:pic>
            <p:nvPicPr>
              <p:cNvPr id="111" name="그림 110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361619" y="1429266"/>
                <a:ext cx="8134350" cy="4800600"/>
              </a:xfrm>
              <a:prstGeom prst="rect">
                <a:avLst/>
              </a:prstGeom>
            </p:spPr>
          </p:pic>
          <p:sp>
            <p:nvSpPr>
              <p:cNvPr id="112" name="직사각형 111"/>
              <p:cNvSpPr/>
              <p:nvPr/>
            </p:nvSpPr>
            <p:spPr>
              <a:xfrm>
                <a:off x="2057400" y="1524000"/>
                <a:ext cx="7302500" cy="40894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pic>
            <p:nvPicPr>
              <p:cNvPr id="113" name="그림 112"/>
              <p:cNvPicPr>
                <a:picLocks noChangeAspect="1"/>
              </p:cNvPicPr>
              <p:nvPr/>
            </p:nvPicPr>
            <p:blipFill rotWithShape="1">
              <a:blip r:embed="rId3"/>
              <a:srcRect l="8743" t="6063" r="84387" b="76477"/>
              <a:stretch/>
            </p:blipFill>
            <p:spPr>
              <a:xfrm>
                <a:off x="1790700" y="1695966"/>
                <a:ext cx="558800" cy="838200"/>
              </a:xfrm>
              <a:prstGeom prst="rect">
                <a:avLst/>
              </a:prstGeom>
            </p:spPr>
          </p:pic>
          <p:pic>
            <p:nvPicPr>
              <p:cNvPr id="114" name="그림 113"/>
              <p:cNvPicPr>
                <a:picLocks noChangeAspect="1"/>
              </p:cNvPicPr>
              <p:nvPr/>
            </p:nvPicPr>
            <p:blipFill rotWithShape="1">
              <a:blip r:embed="rId2"/>
              <a:srcRect l="8625" t="5412" r="5660" b="17868"/>
              <a:stretch/>
            </p:blipFill>
            <p:spPr>
              <a:xfrm>
                <a:off x="2349501" y="1695966"/>
                <a:ext cx="6120281" cy="3683001"/>
              </a:xfrm>
              <a:prstGeom prst="rect">
                <a:avLst/>
              </a:prstGeom>
            </p:spPr>
          </p:pic>
          <p:cxnSp>
            <p:nvCxnSpPr>
              <p:cNvPr id="115" name="직선 연결선 114"/>
              <p:cNvCxnSpPr/>
              <p:nvPr/>
            </p:nvCxnSpPr>
            <p:spPr>
              <a:xfrm>
                <a:off x="2349500" y="1524000"/>
                <a:ext cx="0" cy="4432300"/>
              </a:xfrm>
              <a:prstGeom prst="line">
                <a:avLst/>
              </a:prstGeom>
              <a:ln w="2857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6" name="TextBox 115"/>
              <p:cNvSpPr txBox="1"/>
              <p:nvPr/>
            </p:nvSpPr>
            <p:spPr>
              <a:xfrm>
                <a:off x="941665" y="1617658"/>
                <a:ext cx="742028" cy="58696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  <a:p>
                <a:pPr algn="r"/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(%)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TextBox 116"/>
              <p:cNvSpPr txBox="1"/>
              <p:nvPr/>
            </p:nvSpPr>
            <p:spPr>
              <a:xfrm>
                <a:off x="908615" y="2322250"/>
                <a:ext cx="757086" cy="37352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TextBox 117"/>
              <p:cNvSpPr txBox="1"/>
              <p:nvPr/>
            </p:nvSpPr>
            <p:spPr>
              <a:xfrm>
                <a:off x="980423" y="3180029"/>
                <a:ext cx="700199" cy="37352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TextBox 118"/>
              <p:cNvSpPr txBox="1"/>
              <p:nvPr/>
            </p:nvSpPr>
            <p:spPr>
              <a:xfrm>
                <a:off x="1028232" y="3966109"/>
                <a:ext cx="659115" cy="37352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TextBox 119"/>
              <p:cNvSpPr txBox="1"/>
              <p:nvPr/>
            </p:nvSpPr>
            <p:spPr>
              <a:xfrm>
                <a:off x="982371" y="4752187"/>
                <a:ext cx="704976" cy="37352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TextBox 120"/>
              <p:cNvSpPr txBox="1"/>
              <p:nvPr/>
            </p:nvSpPr>
            <p:spPr>
              <a:xfrm>
                <a:off x="1044901" y="5571867"/>
                <a:ext cx="635721" cy="37352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TextBox 121"/>
              <p:cNvSpPr txBox="1"/>
              <p:nvPr/>
            </p:nvSpPr>
            <p:spPr>
              <a:xfrm>
                <a:off x="4005487" y="5967577"/>
                <a:ext cx="471456" cy="37352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TextBox 122"/>
              <p:cNvSpPr txBox="1"/>
              <p:nvPr/>
            </p:nvSpPr>
            <p:spPr>
              <a:xfrm>
                <a:off x="6027114" y="5972041"/>
                <a:ext cx="471456" cy="37352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TextBox 123"/>
              <p:cNvSpPr txBox="1"/>
              <p:nvPr/>
            </p:nvSpPr>
            <p:spPr>
              <a:xfrm>
                <a:off x="7950817" y="5956300"/>
                <a:ext cx="459413" cy="37352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TextBox 125"/>
              <p:cNvSpPr txBox="1"/>
              <p:nvPr/>
            </p:nvSpPr>
            <p:spPr>
              <a:xfrm>
                <a:off x="1942978" y="5959560"/>
                <a:ext cx="1628790" cy="58696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n-hospital </a:t>
                </a:r>
              </a:p>
              <a:p>
                <a:pPr algn="ctr"/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ortality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TextBox 126"/>
              <p:cNvSpPr txBox="1"/>
              <p:nvPr/>
            </p:nvSpPr>
            <p:spPr>
              <a:xfrm rot="16200000">
                <a:off x="-673309" y="3748743"/>
                <a:ext cx="2908918" cy="57832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verall survival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TextBox 124"/>
              <p:cNvSpPr txBox="1"/>
              <p:nvPr/>
            </p:nvSpPr>
            <p:spPr>
              <a:xfrm flipH="1">
                <a:off x="1734144" y="5955031"/>
                <a:ext cx="217081" cy="37352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8" name="직사각형 127"/>
            <p:cNvSpPr/>
            <p:nvPr/>
          </p:nvSpPr>
          <p:spPr>
            <a:xfrm>
              <a:off x="3100842" y="3818046"/>
              <a:ext cx="437646" cy="50000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29" name="TextBox 28"/>
          <p:cNvSpPr txBox="1"/>
          <p:nvPr/>
        </p:nvSpPr>
        <p:spPr>
          <a:xfrm>
            <a:off x="8118008" y="6345031"/>
            <a:ext cx="9787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4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8118008" y="5290460"/>
            <a:ext cx="19997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8118010" y="5514034"/>
            <a:ext cx="9103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1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8118009" y="5791033"/>
            <a:ext cx="9103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2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8118008" y="6068032"/>
            <a:ext cx="9103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3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9037130" y="5521292"/>
            <a:ext cx="4859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38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9037129" y="5793115"/>
            <a:ext cx="4859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97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9037128" y="6080469"/>
            <a:ext cx="4859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5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9702411" y="5521292"/>
            <a:ext cx="5086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07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9702410" y="5793115"/>
            <a:ext cx="5086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9702409" y="6080469"/>
            <a:ext cx="5086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82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0601881" y="5513716"/>
            <a:ext cx="46704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81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10601881" y="5784758"/>
            <a:ext cx="46704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24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10601881" y="6063521"/>
            <a:ext cx="46704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36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11615425" y="5522563"/>
            <a:ext cx="5108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59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1615424" y="5794386"/>
            <a:ext cx="5108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03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1615423" y="6081740"/>
            <a:ext cx="5108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0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9037128" y="6345031"/>
            <a:ext cx="4859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06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9702409" y="6345031"/>
            <a:ext cx="5086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27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10601881" y="6345410"/>
            <a:ext cx="46704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1615423" y="6346302"/>
            <a:ext cx="5108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59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8721737" y="5521292"/>
            <a:ext cx="4859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44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8721736" y="5793115"/>
            <a:ext cx="4859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02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8721735" y="6080469"/>
            <a:ext cx="4859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62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8721735" y="6345031"/>
            <a:ext cx="4859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24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1" name="그룹 80"/>
          <p:cNvGrpSpPr/>
          <p:nvPr/>
        </p:nvGrpSpPr>
        <p:grpSpPr>
          <a:xfrm>
            <a:off x="3983046" y="1821509"/>
            <a:ext cx="4587285" cy="3460882"/>
            <a:chOff x="3286350" y="1308510"/>
            <a:chExt cx="4587285" cy="3460882"/>
          </a:xfrm>
        </p:grpSpPr>
        <p:grpSp>
          <p:nvGrpSpPr>
            <p:cNvPr id="55" name="그룹 54"/>
            <p:cNvGrpSpPr/>
            <p:nvPr/>
          </p:nvGrpSpPr>
          <p:grpSpPr>
            <a:xfrm>
              <a:off x="3286350" y="1308510"/>
              <a:ext cx="4587285" cy="3460882"/>
              <a:chOff x="257418" y="1524000"/>
              <a:chExt cx="7692782" cy="4306783"/>
            </a:xfrm>
          </p:grpSpPr>
          <p:pic>
            <p:nvPicPr>
              <p:cNvPr id="56" name="그림 55"/>
              <p:cNvPicPr preferRelativeResize="0">
                <a:picLocks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800100" y="1781388"/>
                <a:ext cx="6908799" cy="3655602"/>
              </a:xfrm>
              <a:prstGeom prst="rect">
                <a:avLst/>
              </a:prstGeom>
            </p:spPr>
          </p:pic>
          <p:sp>
            <p:nvSpPr>
              <p:cNvPr id="57" name="직사각형 56"/>
              <p:cNvSpPr/>
              <p:nvPr/>
            </p:nvSpPr>
            <p:spPr>
              <a:xfrm>
                <a:off x="1244600" y="1524000"/>
                <a:ext cx="6705600" cy="35306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pic>
            <p:nvPicPr>
              <p:cNvPr id="58" name="그림 57"/>
              <p:cNvPicPr>
                <a:picLocks noChangeAspect="1"/>
              </p:cNvPicPr>
              <p:nvPr/>
            </p:nvPicPr>
            <p:blipFill rotWithShape="1">
              <a:blip r:embed="rId5"/>
              <a:srcRect l="8626" t="5026" r="87471" b="80688"/>
              <a:stretch/>
            </p:blipFill>
            <p:spPr>
              <a:xfrm>
                <a:off x="1244600" y="1890793"/>
                <a:ext cx="317501" cy="685800"/>
              </a:xfrm>
              <a:prstGeom prst="rect">
                <a:avLst/>
              </a:prstGeom>
            </p:spPr>
          </p:pic>
          <p:pic>
            <p:nvPicPr>
              <p:cNvPr id="59" name="그림 58"/>
              <p:cNvPicPr>
                <a:picLocks noChangeAspect="1"/>
              </p:cNvPicPr>
              <p:nvPr/>
            </p:nvPicPr>
            <p:blipFill rotWithShape="1">
              <a:blip r:embed="rId4"/>
              <a:srcRect l="8497" t="5345" r="5788" b="15776"/>
              <a:stretch/>
            </p:blipFill>
            <p:spPr>
              <a:xfrm>
                <a:off x="1562101" y="1903493"/>
                <a:ext cx="5438288" cy="3070800"/>
              </a:xfrm>
              <a:prstGeom prst="rect">
                <a:avLst/>
              </a:prstGeom>
            </p:spPr>
          </p:pic>
          <p:cxnSp>
            <p:nvCxnSpPr>
              <p:cNvPr id="60" name="직선 연결선 59"/>
              <p:cNvCxnSpPr/>
              <p:nvPr/>
            </p:nvCxnSpPr>
            <p:spPr>
              <a:xfrm>
                <a:off x="1562101" y="1795890"/>
                <a:ext cx="10334" cy="3393219"/>
              </a:xfrm>
              <a:prstGeom prst="line">
                <a:avLst/>
              </a:prstGeom>
              <a:ln w="2857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TextBox 60"/>
              <p:cNvSpPr txBox="1"/>
              <p:nvPr/>
            </p:nvSpPr>
            <p:spPr>
              <a:xfrm>
                <a:off x="429573" y="1879733"/>
                <a:ext cx="617799" cy="42130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  <a:p>
                <a:pPr algn="r"/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(%)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558803" y="2535113"/>
                <a:ext cx="504023" cy="26810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526521" y="3142134"/>
                <a:ext cx="516823" cy="26810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526518" y="3770633"/>
                <a:ext cx="522594" cy="26810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509408" y="4344947"/>
                <a:ext cx="529377" cy="26810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539808" y="4947285"/>
                <a:ext cx="503535" cy="26810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 rot="16200000">
                <a:off x="-461996" y="3399061"/>
                <a:ext cx="1822731" cy="38390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verall survival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>
                <a:off x="3235711" y="5212235"/>
                <a:ext cx="404461" cy="26810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4778009" y="5213141"/>
                <a:ext cx="404461" cy="26810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6350722" y="5197246"/>
                <a:ext cx="577044" cy="26810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1166041" y="5200092"/>
                <a:ext cx="246659" cy="26810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1432546" y="5219661"/>
                <a:ext cx="1190412" cy="42130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n-hospital </a:t>
                </a:r>
              </a:p>
              <a:p>
                <a:pPr algn="ctr"/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ortality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직사각형 72"/>
              <p:cNvSpPr/>
              <p:nvPr/>
            </p:nvSpPr>
            <p:spPr>
              <a:xfrm>
                <a:off x="5182469" y="5283748"/>
                <a:ext cx="507999" cy="22197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2410035" y="5486081"/>
                <a:ext cx="4427627" cy="34470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ollow-up after discharge (years) 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6" name="직사각형 75"/>
            <p:cNvSpPr/>
            <p:nvPr/>
          </p:nvSpPr>
          <p:spPr>
            <a:xfrm>
              <a:off x="7252112" y="4321125"/>
              <a:ext cx="423517" cy="13386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7" name="직사각형 76"/>
            <p:cNvSpPr/>
            <p:nvPr/>
          </p:nvSpPr>
          <p:spPr>
            <a:xfrm>
              <a:off x="3949054" y="4335320"/>
              <a:ext cx="94782" cy="42036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9" name="직사각형 78"/>
            <p:cNvSpPr/>
            <p:nvPr/>
          </p:nvSpPr>
          <p:spPr>
            <a:xfrm>
              <a:off x="7368376" y="4278253"/>
              <a:ext cx="195942" cy="14962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0" name="직사각형 79"/>
            <p:cNvSpPr/>
            <p:nvPr/>
          </p:nvSpPr>
          <p:spPr>
            <a:xfrm>
              <a:off x="6215304" y="4277682"/>
              <a:ext cx="195942" cy="14962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82" name="TextBox 81"/>
          <p:cNvSpPr txBox="1"/>
          <p:nvPr/>
        </p:nvSpPr>
        <p:spPr>
          <a:xfrm>
            <a:off x="4810644" y="4086359"/>
            <a:ext cx="146287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-hospital mortality:  </a:t>
            </a:r>
          </a:p>
          <a:p>
            <a:pPr algn="r"/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fter discharge: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6122903" y="4088210"/>
            <a:ext cx="120898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 =0.004</a:t>
            </a:r>
          </a:p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 &lt;0.001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3820240" y="6345031"/>
            <a:ext cx="8089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4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3924480" y="5293267"/>
            <a:ext cx="19997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3814307" y="5514034"/>
            <a:ext cx="7523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1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3814306" y="5791033"/>
            <a:ext cx="7523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2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3814305" y="6068032"/>
            <a:ext cx="7523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3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4736237" y="5527866"/>
            <a:ext cx="4015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84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4736236" y="5799689"/>
            <a:ext cx="4015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99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4736235" y="6087043"/>
            <a:ext cx="4015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5661970" y="5521292"/>
            <a:ext cx="3821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69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5661969" y="5793115"/>
            <a:ext cx="3821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74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5661968" y="6080469"/>
            <a:ext cx="3821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63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6583339" y="5515229"/>
            <a:ext cx="3859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6583339" y="5786271"/>
            <a:ext cx="3859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51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6583339" y="6065034"/>
            <a:ext cx="3859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36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7672678" y="5522690"/>
            <a:ext cx="3837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38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7672677" y="5794513"/>
            <a:ext cx="3837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38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7672676" y="6081867"/>
            <a:ext cx="3837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17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4736235" y="6351605"/>
            <a:ext cx="4015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23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5661968" y="6345031"/>
            <a:ext cx="3821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66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6583339" y="6346923"/>
            <a:ext cx="3859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33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7672676" y="6346429"/>
            <a:ext cx="3837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18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4400426" y="5530857"/>
            <a:ext cx="4015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87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4400425" y="5802680"/>
            <a:ext cx="4015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04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4400424" y="6090034"/>
            <a:ext cx="4015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0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4400424" y="6354596"/>
            <a:ext cx="4015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41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직사각형 108"/>
          <p:cNvSpPr/>
          <p:nvPr/>
        </p:nvSpPr>
        <p:spPr>
          <a:xfrm>
            <a:off x="8023476" y="4584031"/>
            <a:ext cx="388158" cy="39085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pSp>
        <p:nvGrpSpPr>
          <p:cNvPr id="132" name="그룹 131"/>
          <p:cNvGrpSpPr/>
          <p:nvPr/>
        </p:nvGrpSpPr>
        <p:grpSpPr>
          <a:xfrm>
            <a:off x="8097647" y="1992050"/>
            <a:ext cx="4469001" cy="3222970"/>
            <a:chOff x="7850592" y="1486584"/>
            <a:chExt cx="4451256" cy="3222970"/>
          </a:xfrm>
        </p:grpSpPr>
        <p:grpSp>
          <p:nvGrpSpPr>
            <p:cNvPr id="75" name="그룹 74"/>
            <p:cNvGrpSpPr/>
            <p:nvPr/>
          </p:nvGrpSpPr>
          <p:grpSpPr>
            <a:xfrm>
              <a:off x="7850592" y="1486584"/>
              <a:ext cx="4451256" cy="3222970"/>
              <a:chOff x="7796162" y="1508356"/>
              <a:chExt cx="4451256" cy="3222970"/>
            </a:xfrm>
          </p:grpSpPr>
          <p:grpSp>
            <p:nvGrpSpPr>
              <p:cNvPr id="26" name="그룹 25"/>
              <p:cNvGrpSpPr/>
              <p:nvPr/>
            </p:nvGrpSpPr>
            <p:grpSpPr>
              <a:xfrm>
                <a:off x="7796162" y="1508356"/>
                <a:ext cx="4451256" cy="3222970"/>
                <a:chOff x="-106192" y="1022473"/>
                <a:chExt cx="8837896" cy="5268031"/>
              </a:xfrm>
            </p:grpSpPr>
            <p:pic>
              <p:nvPicPr>
                <p:cNvPr id="9" name="그림 8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597354" y="1022473"/>
                  <a:ext cx="8134350" cy="4800600"/>
                </a:xfrm>
                <a:prstGeom prst="rect">
                  <a:avLst/>
                </a:prstGeom>
              </p:spPr>
            </p:pic>
            <p:pic>
              <p:nvPicPr>
                <p:cNvPr id="5" name="그림 4"/>
                <p:cNvPicPr>
                  <a:picLocks noChangeAspect="1"/>
                </p:cNvPicPr>
                <p:nvPr/>
              </p:nvPicPr>
              <p:blipFill rotWithShape="1">
                <a:blip r:embed="rId7"/>
                <a:srcRect l="8916" t="11127" r="86400" b="78896"/>
                <a:stretch/>
              </p:blipFill>
              <p:spPr>
                <a:xfrm>
                  <a:off x="1095374" y="1294615"/>
                  <a:ext cx="381001" cy="478972"/>
                </a:xfrm>
                <a:prstGeom prst="rect">
                  <a:avLst/>
                </a:prstGeom>
              </p:spPr>
            </p:pic>
            <p:sp>
              <p:nvSpPr>
                <p:cNvPr id="10" name="직사각형 9"/>
                <p:cNvSpPr/>
                <p:nvPr/>
              </p:nvSpPr>
              <p:spPr>
                <a:xfrm>
                  <a:off x="1285875" y="1153885"/>
                  <a:ext cx="7128782" cy="4180115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pic>
              <p:nvPicPr>
                <p:cNvPr id="8" name="그림 7"/>
                <p:cNvPicPr>
                  <a:picLocks noChangeAspect="1"/>
                </p:cNvPicPr>
                <p:nvPr/>
              </p:nvPicPr>
              <p:blipFill rotWithShape="1">
                <a:blip r:embed="rId6"/>
                <a:srcRect l="8448" t="5005" r="6307" b="14497"/>
                <a:stretch/>
              </p:blipFill>
              <p:spPr>
                <a:xfrm>
                  <a:off x="1310691" y="1283729"/>
                  <a:ext cx="6290712" cy="3864428"/>
                </a:xfrm>
                <a:prstGeom prst="rect">
                  <a:avLst/>
                </a:prstGeom>
              </p:spPr>
            </p:pic>
            <p:cxnSp>
              <p:nvCxnSpPr>
                <p:cNvPr id="11" name="직선 연결선 10"/>
                <p:cNvCxnSpPr/>
                <p:nvPr/>
              </p:nvCxnSpPr>
              <p:spPr>
                <a:xfrm flipH="1">
                  <a:off x="1285875" y="1104937"/>
                  <a:ext cx="21058" cy="4414118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" name="TextBox 12"/>
                <p:cNvSpPr txBox="1"/>
                <p:nvPr/>
              </p:nvSpPr>
              <p:spPr>
                <a:xfrm>
                  <a:off x="-106192" y="1231073"/>
                  <a:ext cx="1032454" cy="55337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</a:p>
                <a:p>
                  <a:pPr algn="r"/>
                  <a:r>
                    <a:rPr lang="en-US" altLang="ko-KR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(%)</a:t>
                  </a:r>
                  <a:endParaRPr lang="ko-KR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91848" y="1958143"/>
                  <a:ext cx="802782" cy="35214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90</a:t>
                  </a:r>
                  <a:endParaRPr lang="ko-KR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91848" y="2736301"/>
                  <a:ext cx="831513" cy="35214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80</a:t>
                  </a:r>
                  <a:endParaRPr lang="ko-KR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91848" y="3559200"/>
                  <a:ext cx="820592" cy="35214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  <a:r>
                    <a:rPr lang="en-US" altLang="ko-KR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ko-KR" alt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91850" y="4373756"/>
                  <a:ext cx="820594" cy="35214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  <a:endParaRPr lang="ko-KR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299818" y="5189989"/>
                  <a:ext cx="626444" cy="35214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ko-KR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 rot="16200000">
                  <a:off x="-1090352" y="3244791"/>
                  <a:ext cx="2545400" cy="54997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Overall survival</a:t>
                  </a:r>
                  <a:endParaRPr lang="ko-KR" alt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3297184" y="5556051"/>
                  <a:ext cx="444480" cy="35214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ko-KR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4964777" y="5550032"/>
                  <a:ext cx="444481" cy="35214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ko-KR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6952998" y="5566938"/>
                  <a:ext cx="634142" cy="35214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ko-KR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919246" y="5566938"/>
                  <a:ext cx="270804" cy="40245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ko-KR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1193736" y="5553408"/>
                  <a:ext cx="1583275" cy="55337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In-hospital </a:t>
                  </a:r>
                </a:p>
                <a:p>
                  <a:pPr algn="ctr"/>
                  <a:r>
                    <a:rPr lang="en-US" altLang="ko-KR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ortality</a:t>
                  </a:r>
                  <a:endParaRPr lang="ko-KR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2398909" y="5837742"/>
                  <a:ext cx="5722424" cy="45276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Follow-up after discharge (years)</a:t>
                  </a:r>
                  <a:endParaRPr lang="ko-KR" alt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7" name="TextBox 26"/>
              <p:cNvSpPr txBox="1"/>
              <p:nvPr/>
            </p:nvSpPr>
            <p:spPr>
              <a:xfrm>
                <a:off x="7969118" y="3669943"/>
                <a:ext cx="235597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n-hospital mortality:  </a:t>
                </a:r>
              </a:p>
              <a:p>
                <a:pPr algn="r"/>
                <a:r>
                  <a:rPr lang="en-US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fter discharge: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10164585" y="3669939"/>
                <a:ext cx="120898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 =0.024</a:t>
                </a:r>
              </a:p>
              <a:p>
                <a:r>
                  <a:rPr lang="en-US" altLang="ko-KR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 &lt;0.001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1" name="직사각형 130"/>
            <p:cNvSpPr/>
            <p:nvPr/>
          </p:nvSpPr>
          <p:spPr>
            <a:xfrm>
              <a:off x="11732698" y="3500902"/>
              <a:ext cx="513187" cy="9144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133" name="직사각형 132"/>
          <p:cNvSpPr/>
          <p:nvPr/>
        </p:nvSpPr>
        <p:spPr>
          <a:xfrm>
            <a:off x="11028616" y="4796282"/>
            <a:ext cx="290604" cy="1088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5" name="TextBox 134"/>
          <p:cNvSpPr txBox="1"/>
          <p:nvPr/>
        </p:nvSpPr>
        <p:spPr>
          <a:xfrm>
            <a:off x="5458378" y="1571026"/>
            <a:ext cx="194044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FmrEF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40% ≤ LVEF&lt;50%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1439653" y="1573692"/>
            <a:ext cx="124564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FrEF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LVEF &lt;40%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직사각형 136"/>
          <p:cNvSpPr/>
          <p:nvPr/>
        </p:nvSpPr>
        <p:spPr>
          <a:xfrm flipH="1">
            <a:off x="2911945" y="4779613"/>
            <a:ext cx="223142" cy="24156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8" name="TextBox 137"/>
          <p:cNvSpPr txBox="1"/>
          <p:nvPr/>
        </p:nvSpPr>
        <p:spPr>
          <a:xfrm>
            <a:off x="1184752" y="5039825"/>
            <a:ext cx="274920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ollow-up after discharge (years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9228" y="6357196"/>
            <a:ext cx="8089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4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-72009" y="5272284"/>
            <a:ext cx="19997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3295" y="5526199"/>
            <a:ext cx="7523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1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3294" y="5803198"/>
            <a:ext cx="7523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2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3293" y="6080197"/>
            <a:ext cx="7523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3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927866" y="5533962"/>
            <a:ext cx="4015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62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927865" y="5805785"/>
            <a:ext cx="4015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808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927864" y="6093139"/>
            <a:ext cx="4015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2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1641349" y="5521292"/>
            <a:ext cx="3821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76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1641348" y="5793115"/>
            <a:ext cx="3821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8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1641347" y="6080469"/>
            <a:ext cx="3821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6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2579383" y="5513716"/>
            <a:ext cx="3859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07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2579383" y="5784758"/>
            <a:ext cx="3859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21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2579383" y="6063521"/>
            <a:ext cx="3859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9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3502799" y="5527866"/>
            <a:ext cx="3837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74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3502798" y="5799689"/>
            <a:ext cx="3837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64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3474551" y="6087043"/>
            <a:ext cx="3837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29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927864" y="6357701"/>
            <a:ext cx="4015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79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1641347" y="6345031"/>
            <a:ext cx="3821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87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2579383" y="6345410"/>
            <a:ext cx="3859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27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3474551" y="6351605"/>
            <a:ext cx="3837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72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601167" y="5527866"/>
            <a:ext cx="4015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92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601166" y="5799689"/>
            <a:ext cx="4015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836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601165" y="6087043"/>
            <a:ext cx="4015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63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601165" y="6351605"/>
            <a:ext cx="4015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5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Box 163"/>
          <p:cNvSpPr txBox="1"/>
          <p:nvPr/>
        </p:nvSpPr>
        <p:spPr>
          <a:xfrm>
            <a:off x="257851" y="246670"/>
            <a:ext cx="117496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.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Overall in-hospital mortality and post discharge 3-year mortality in HF patients subgroup analysis </a:t>
            </a:r>
            <a:r>
              <a:rPr lang="en-US" altLang="ko-KR" dirty="0" smtClean="0">
                <a:latin typeface="Arial" panose="020B0604020202020204" pitchFamily="34" charset="0"/>
                <a:cs typeface="Arial" panose="020B0604020202020204" pitchFamily="34" charset="0"/>
              </a:rPr>
              <a:t>by LVEF categories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5" name="직선 연결선 164"/>
          <p:cNvCxnSpPr/>
          <p:nvPr/>
        </p:nvCxnSpPr>
        <p:spPr>
          <a:xfrm>
            <a:off x="9811931" y="1057112"/>
            <a:ext cx="29203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66" name="직선 연결선 165"/>
          <p:cNvCxnSpPr/>
          <p:nvPr/>
        </p:nvCxnSpPr>
        <p:spPr>
          <a:xfrm>
            <a:off x="9811931" y="840993"/>
            <a:ext cx="292034" cy="0"/>
          </a:xfrm>
          <a:prstGeom prst="line">
            <a:avLst/>
          </a:prstGeom>
          <a:ln>
            <a:solidFill>
              <a:srgbClr val="0000FF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67" name="직선 연결선 166"/>
          <p:cNvCxnSpPr/>
          <p:nvPr/>
        </p:nvCxnSpPr>
        <p:spPr>
          <a:xfrm>
            <a:off x="9811931" y="1274365"/>
            <a:ext cx="292034" cy="0"/>
          </a:xfrm>
          <a:prstGeom prst="line">
            <a:avLst/>
          </a:prstGeom>
          <a:ln>
            <a:solidFill>
              <a:schemeClr val="accent6">
                <a:lumMod val="75000"/>
              </a:schemeClr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68" name="TextBox 167"/>
          <p:cNvSpPr txBox="1"/>
          <p:nvPr/>
        </p:nvSpPr>
        <p:spPr>
          <a:xfrm>
            <a:off x="10103964" y="704097"/>
            <a:ext cx="18614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1 (0.2–2.0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Box 168"/>
          <p:cNvSpPr txBox="1"/>
          <p:nvPr/>
        </p:nvSpPr>
        <p:spPr>
          <a:xfrm>
            <a:off x="10103965" y="918044"/>
            <a:ext cx="14642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2 (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.1–3.2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Box 169"/>
          <p:cNvSpPr txBox="1"/>
          <p:nvPr/>
        </p:nvSpPr>
        <p:spPr>
          <a:xfrm>
            <a:off x="10103964" y="1135866"/>
            <a:ext cx="14931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3 (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.3–5.8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1" name="직선 연결선 170"/>
          <p:cNvCxnSpPr/>
          <p:nvPr/>
        </p:nvCxnSpPr>
        <p:spPr>
          <a:xfrm>
            <a:off x="9823506" y="1497787"/>
            <a:ext cx="292034" cy="0"/>
          </a:xfrm>
          <a:prstGeom prst="line">
            <a:avLst/>
          </a:prstGeom>
          <a:ln>
            <a:solidFill>
              <a:srgbClr val="FF66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72" name="TextBox 171"/>
          <p:cNvSpPr txBox="1"/>
          <p:nvPr/>
        </p:nvSpPr>
        <p:spPr>
          <a:xfrm>
            <a:off x="10103964" y="1353688"/>
            <a:ext cx="1736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Quartile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4 (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.9–192.4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9675020" y="1577458"/>
            <a:ext cx="13142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FpEF</a:t>
            </a:r>
            <a:endParaRPr lang="en-US" altLang="ko-K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LVEF ≥50%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44835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509</Words>
  <Application>Microsoft Office PowerPoint</Application>
  <PresentationFormat>와이드스크린</PresentationFormat>
  <Paragraphs>267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5" baseType="lpstr">
      <vt:lpstr>맑은 고딕</vt:lpstr>
      <vt:lpstr>Arial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조 준환</dc:creator>
  <cp:lastModifiedBy>조 준환</cp:lastModifiedBy>
  <cp:revision>3</cp:revision>
  <dcterms:created xsi:type="dcterms:W3CDTF">2020-01-14T11:04:59Z</dcterms:created>
  <dcterms:modified xsi:type="dcterms:W3CDTF">2020-01-14T11:10:35Z</dcterms:modified>
</cp:coreProperties>
</file>